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47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378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1A9220-1C7E-9535-B958-A8174683A8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C8506AC-6409-5DC9-1989-14A6FC6F9C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6AB8A19-41BA-1C1D-D094-08483AF36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842B08B-4E02-F342-E845-85F058F8B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D0FA68-2F49-3FE7-A88C-DB1FF6E39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1719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ABC445-CA4E-E1E3-F5AB-CBEC48EDA2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FDDCEBB-0425-58FE-E343-186523C01F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E1EF85-3258-4EB4-8EDA-DB3C9C4BD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15BE412-8231-8318-9791-238FEC3F2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AD98BA3-E0D3-ADDA-A22B-EF53C6C7F7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307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ABE9C70-12D8-4C33-DAB0-666C229A4B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059ED73-6CA6-BE50-3DA8-8E4BBAA86B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A79EE73-8EB9-C89B-023F-183697A02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ABC651-BAEF-09B6-C3C9-9E91DE4DA3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C624CC-DDFA-BA73-D60A-D2E17F154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6125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D077FC-D316-FEF1-1A3C-30B2FCB120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311113-E5EB-C0F9-E9B3-B6E888617F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CFB692-1642-FA49-E685-38B200C75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DF17AE-254F-B6A4-D913-8057D9FC9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4381F5-B62C-AC6B-153F-7F8ADDE6A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886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83D8192-4BF1-9319-2983-4E3F472165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F39082-2834-E31D-C0AC-D05100468C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D171C2-E64D-3F45-D62F-219FB4F326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BE44E7-5803-819F-7F91-C695914F5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99AAD9-3D95-EC26-8A87-D7892B178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1406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2A86A3-2700-8492-34C6-E390125C4E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53B2308-182C-D3EC-5C71-DE9443ADE2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E67BDEE-95F8-3EF5-E9BA-CC1A9B125A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2F70D9B-BAC5-A888-32B7-BFD1F1615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0316274-69A7-2DA5-BB66-4D486971F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1419A30-80EB-27E2-9F93-252CD439B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59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0D8E0D-960F-B026-2EF7-9CF3E5185E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651A320-C43E-5E1E-5AA8-68ECCDC0D9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ACA251C-6B46-5E9A-750F-A3666CD90F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83A1FFC-C3B0-0157-7047-354C1CCF38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BA819FB-BA16-AE74-C93D-8B2CCCED57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2EE1467-D002-0540-D860-EFCC928FD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4DE16D3-F566-57F1-0CB5-368B8DAA3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80A78B8-F02E-4518-6425-E35E8137E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9846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EC0902-995C-2347-2418-B20DF3BB7B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9E9FFDE-211E-854E-72F8-EA791D7EA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C2767BF-2DBB-D709-8D12-F52AE35DE2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9BBDA7F-9A44-7D7A-8143-81B00D00D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5819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DA499F4-19DE-5AAF-D979-E9B0443EB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D55C61E-00E1-79D1-8DAF-221C9FC423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37151C1-A020-D45B-E088-D8489DD67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2834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1A8184-6D73-2AD7-E44D-D058F9529F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B062F9D-94AC-30FF-6AFB-8A14F8C9A4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32A21C0-106E-207A-B0C1-71714901ED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5E61C9B-6CCA-C078-097C-FBF82A3A5A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E0BBC8D-E615-72F1-CE22-24F54A4EC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D5A21A2-F665-7690-02EE-F1280031A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7293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6D700F-388B-408B-7D64-F7F7A1FC7E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834EF74-44F1-785E-E7D7-C7EB9DC498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B7505C3-94B9-27F1-C469-DB6FD0D0EB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5DAB4A0-A0F9-E5DB-C775-0F396ECAB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1C8FA0B-030F-E9FE-F16D-20C7D1313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224D956-ADE9-2721-5D1B-E224FDFFB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2959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FBE3F99-68F9-765B-CD5F-E4F785A97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6E56AAD-AD2B-C0B3-0C81-2EC0A2AE8E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511EFED-EE06-77F9-1EA5-7FF0D91DEF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4E8285-3770-4281-B21F-8B94C6003CFF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D5FA5CB-0440-2071-4491-15DFC5F549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F9E773-439F-0912-A425-0304EC6883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E65FB81-CCF1-4985-AACD-42C17C4893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5248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4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image" Target="../media/image3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2.png"/><Relationship Id="rId5" Type="http://schemas.microsoft.com/office/2007/relationships/media" Target="../media/media3.mp4"/><Relationship Id="rId10" Type="http://schemas.openxmlformats.org/officeDocument/2006/relationships/image" Target="../media/image1.png"/><Relationship Id="rId4" Type="http://schemas.openxmlformats.org/officeDocument/2006/relationships/video" Target="../media/media2.mp4"/><Relationship Id="rId9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HR_Image_45~90minCH1">
            <a:hlinkClick r:id="" action="ppaction://media"/>
            <a:extLst>
              <a:ext uri="{FF2B5EF4-FFF2-40B4-BE49-F238E27FC236}">
                <a16:creationId xmlns:a16="http://schemas.microsoft.com/office/drawing/2014/main" id="{68DEF00A-E413-4E33-9192-3E0E170B047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1689094" y="633798"/>
            <a:ext cx="2880000" cy="2160000"/>
          </a:xfrm>
          <a:prstGeom prst="rect">
            <a:avLst/>
          </a:prstGeom>
        </p:spPr>
      </p:pic>
      <p:pic>
        <p:nvPicPr>
          <p:cNvPr id="9" name="Image_45~90minOverlay">
            <a:hlinkClick r:id="" action="ppaction://media"/>
            <a:extLst>
              <a:ext uri="{FF2B5EF4-FFF2-40B4-BE49-F238E27FC236}">
                <a16:creationId xmlns:a16="http://schemas.microsoft.com/office/drawing/2014/main" id="{AA6FF15A-995B-43DC-BA89-F46CF06451B4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4584772" y="633456"/>
            <a:ext cx="2880000" cy="21600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0E706A6-D6A0-481A-BF33-329D40D3288A}"/>
              </a:ext>
            </a:extLst>
          </p:cNvPr>
          <p:cNvSpPr txBox="1"/>
          <p:nvPr/>
        </p:nvSpPr>
        <p:spPr>
          <a:xfrm>
            <a:off x="1062219" y="71287"/>
            <a:ext cx="69735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/>
              <a:t>A, </a:t>
            </a:r>
            <a:r>
              <a:rPr lang="en-US" altLang="ja-JP" dirty="0"/>
              <a:t>PMC (30 µM)-treated HCT116 </a:t>
            </a:r>
            <a:r>
              <a:rPr kumimoji="1" lang="en-US" altLang="ja-JP" dirty="0"/>
              <a:t>KDELR1-hAG (HCT116K) cells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21F87BA-B7CD-43A5-8B14-67732B380726}"/>
              </a:ext>
            </a:extLst>
          </p:cNvPr>
          <p:cNvSpPr txBox="1"/>
          <p:nvPr/>
        </p:nvSpPr>
        <p:spPr>
          <a:xfrm>
            <a:off x="2370413" y="440619"/>
            <a:ext cx="15231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Green fluorescence</a:t>
            </a:r>
            <a:endParaRPr kumimoji="1" lang="ja-JP" altLang="en-US" sz="12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3B08895-4A1D-4BA3-89EE-343E986F94A3}"/>
              </a:ext>
            </a:extLst>
          </p:cNvPr>
          <p:cNvSpPr txBox="1"/>
          <p:nvPr/>
        </p:nvSpPr>
        <p:spPr>
          <a:xfrm>
            <a:off x="4797506" y="431684"/>
            <a:ext cx="2449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/>
              <a:t>Green fluorescence + Blight field</a:t>
            </a:r>
            <a:endParaRPr kumimoji="1" lang="ja-JP" altLang="en-US" sz="12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3D1CEFB-C1AE-4B6B-A105-1C88550013EE}"/>
              </a:ext>
            </a:extLst>
          </p:cNvPr>
          <p:cNvSpPr txBox="1"/>
          <p:nvPr/>
        </p:nvSpPr>
        <p:spPr>
          <a:xfrm>
            <a:off x="780476" y="1562949"/>
            <a:ext cx="9861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200" dirty="0"/>
              <a:t>45</a:t>
            </a:r>
            <a:r>
              <a:rPr kumimoji="1" lang="en-US" altLang="ja-JP" sz="1200" dirty="0"/>
              <a:t> – 90 min</a:t>
            </a:r>
            <a:endParaRPr kumimoji="1" lang="ja-JP" altLang="en-US" sz="1200" dirty="0"/>
          </a:p>
        </p:txBody>
      </p:sp>
      <p:pic>
        <p:nvPicPr>
          <p:cNvPr id="14" name="Green_CH1">
            <a:hlinkClick r:id="" action="ppaction://media"/>
            <a:extLst>
              <a:ext uri="{FF2B5EF4-FFF2-40B4-BE49-F238E27FC236}">
                <a16:creationId xmlns:a16="http://schemas.microsoft.com/office/drawing/2014/main" id="{08E3FC36-7F4A-4FDE-95EF-7BF75A0D711D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2"/>
          <a:stretch>
            <a:fillRect/>
          </a:stretch>
        </p:blipFill>
        <p:spPr>
          <a:xfrm>
            <a:off x="1692000" y="3404573"/>
            <a:ext cx="2880000" cy="2160000"/>
          </a:xfrm>
          <a:prstGeom prst="rect">
            <a:avLst/>
          </a:prstGeom>
        </p:spPr>
      </p:pic>
      <p:pic>
        <p:nvPicPr>
          <p:cNvPr id="15" name="Image_Overlay">
            <a:hlinkClick r:id="" action="ppaction://media"/>
            <a:extLst>
              <a:ext uri="{FF2B5EF4-FFF2-40B4-BE49-F238E27FC236}">
                <a16:creationId xmlns:a16="http://schemas.microsoft.com/office/drawing/2014/main" id="{075E0B28-608A-4355-AA1D-CBDE4A4ECB88}"/>
              </a:ext>
            </a:extLst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3"/>
          <a:stretch>
            <a:fillRect/>
          </a:stretch>
        </p:blipFill>
        <p:spPr>
          <a:xfrm>
            <a:off x="4582362" y="3403030"/>
            <a:ext cx="2880000" cy="2160000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C97450C-42B8-4B6E-9CDE-97CE6137A2BB}"/>
              </a:ext>
            </a:extLst>
          </p:cNvPr>
          <p:cNvSpPr txBox="1"/>
          <p:nvPr/>
        </p:nvSpPr>
        <p:spPr>
          <a:xfrm>
            <a:off x="550408" y="2861432"/>
            <a:ext cx="7997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/>
              <a:t>B, </a:t>
            </a:r>
            <a:r>
              <a:rPr lang="en-US" altLang="ja-JP" dirty="0"/>
              <a:t>PMC (30 µM)-treated </a:t>
            </a:r>
            <a:r>
              <a:rPr kumimoji="1" lang="en-US" altLang="ja-JP" dirty="0"/>
              <a:t>HCT116 KDELR1-hAG+Ash-BiP</a:t>
            </a:r>
            <a:r>
              <a:rPr lang="ja-JP" altLang="en-US" dirty="0"/>
              <a:t> </a:t>
            </a:r>
            <a:r>
              <a:rPr lang="en-US" altLang="ja-JP" dirty="0"/>
              <a:t>(HCT116KB)</a:t>
            </a:r>
            <a:r>
              <a:rPr kumimoji="1" lang="en-US" altLang="ja-JP" dirty="0"/>
              <a:t> cells</a:t>
            </a:r>
            <a:endParaRPr kumimoji="1" lang="ja-JP" altLang="en-US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E4C5904-C051-431A-825C-F8D0E8B0BE4A}"/>
              </a:ext>
            </a:extLst>
          </p:cNvPr>
          <p:cNvSpPr txBox="1"/>
          <p:nvPr/>
        </p:nvSpPr>
        <p:spPr>
          <a:xfrm>
            <a:off x="2370413" y="3230764"/>
            <a:ext cx="15231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Green fluorescence</a:t>
            </a:r>
            <a:endParaRPr kumimoji="1" lang="ja-JP" altLang="en-US" sz="12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C5241D5-83F7-4249-A5A1-D4C93229AB82}"/>
              </a:ext>
            </a:extLst>
          </p:cNvPr>
          <p:cNvSpPr txBox="1"/>
          <p:nvPr/>
        </p:nvSpPr>
        <p:spPr>
          <a:xfrm>
            <a:off x="4797507" y="3230764"/>
            <a:ext cx="2449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/>
              <a:t>Green fluorescence + Blight field</a:t>
            </a:r>
            <a:endParaRPr kumimoji="1" lang="ja-JP" altLang="en-US" sz="12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D839EB3-F5A6-4156-9B69-63737061B7A6}"/>
              </a:ext>
            </a:extLst>
          </p:cNvPr>
          <p:cNvSpPr txBox="1"/>
          <p:nvPr/>
        </p:nvSpPr>
        <p:spPr>
          <a:xfrm>
            <a:off x="866528" y="4344581"/>
            <a:ext cx="901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/>
              <a:t>0 – 90 min</a:t>
            </a:r>
            <a:endParaRPr kumimoji="1" lang="ja-JP" altLang="en-US" sz="1200" dirty="0"/>
          </a:p>
        </p:txBody>
      </p:sp>
      <p:sp>
        <p:nvSpPr>
          <p:cNvPr id="2" name="二等辺三角形 1">
            <a:extLst>
              <a:ext uri="{FF2B5EF4-FFF2-40B4-BE49-F238E27FC236}">
                <a16:creationId xmlns:a16="http://schemas.microsoft.com/office/drawing/2014/main" id="{8256456A-E017-47FF-B523-E110E320BD78}"/>
              </a:ext>
            </a:extLst>
          </p:cNvPr>
          <p:cNvSpPr/>
          <p:nvPr/>
        </p:nvSpPr>
        <p:spPr>
          <a:xfrm rot="13500000">
            <a:off x="3093093" y="1287744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二等辺三角形 19">
            <a:extLst>
              <a:ext uri="{FF2B5EF4-FFF2-40B4-BE49-F238E27FC236}">
                <a16:creationId xmlns:a16="http://schemas.microsoft.com/office/drawing/2014/main" id="{FC074684-514D-4D05-8135-01F342EBCFC1}"/>
              </a:ext>
            </a:extLst>
          </p:cNvPr>
          <p:cNvSpPr/>
          <p:nvPr/>
        </p:nvSpPr>
        <p:spPr>
          <a:xfrm rot="13500000">
            <a:off x="3307408" y="1511586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二等辺三角形 20">
            <a:extLst>
              <a:ext uri="{FF2B5EF4-FFF2-40B4-BE49-F238E27FC236}">
                <a16:creationId xmlns:a16="http://schemas.microsoft.com/office/drawing/2014/main" id="{76ADA454-F991-472E-BACA-2A5F197DFC4A}"/>
              </a:ext>
            </a:extLst>
          </p:cNvPr>
          <p:cNvSpPr/>
          <p:nvPr/>
        </p:nvSpPr>
        <p:spPr>
          <a:xfrm rot="13500000">
            <a:off x="3307402" y="1606837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二等辺三角形 21">
            <a:extLst>
              <a:ext uri="{FF2B5EF4-FFF2-40B4-BE49-F238E27FC236}">
                <a16:creationId xmlns:a16="http://schemas.microsoft.com/office/drawing/2014/main" id="{0FE10837-2904-46D4-A9D8-D2F4E978C008}"/>
              </a:ext>
            </a:extLst>
          </p:cNvPr>
          <p:cNvSpPr/>
          <p:nvPr/>
        </p:nvSpPr>
        <p:spPr>
          <a:xfrm rot="13500000">
            <a:off x="3450276" y="2197398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二等辺三角形 22">
            <a:extLst>
              <a:ext uri="{FF2B5EF4-FFF2-40B4-BE49-F238E27FC236}">
                <a16:creationId xmlns:a16="http://schemas.microsoft.com/office/drawing/2014/main" id="{A8131E18-9AA2-4F64-B390-58006C3D61D3}"/>
              </a:ext>
            </a:extLst>
          </p:cNvPr>
          <p:cNvSpPr/>
          <p:nvPr/>
        </p:nvSpPr>
        <p:spPr>
          <a:xfrm rot="18900000">
            <a:off x="3093094" y="4839806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二等辺三角形 24">
            <a:extLst>
              <a:ext uri="{FF2B5EF4-FFF2-40B4-BE49-F238E27FC236}">
                <a16:creationId xmlns:a16="http://schemas.microsoft.com/office/drawing/2014/main" id="{0E248FD2-884A-4CE9-A1B3-DCBD2DF8FD92}"/>
              </a:ext>
            </a:extLst>
          </p:cNvPr>
          <p:cNvSpPr/>
          <p:nvPr/>
        </p:nvSpPr>
        <p:spPr>
          <a:xfrm rot="8100000">
            <a:off x="2645414" y="4534994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二等辺三角形 25">
            <a:extLst>
              <a:ext uri="{FF2B5EF4-FFF2-40B4-BE49-F238E27FC236}">
                <a16:creationId xmlns:a16="http://schemas.microsoft.com/office/drawing/2014/main" id="{B5CEB1DA-DC2F-4BDF-A4F1-1C4D78190BB9}"/>
              </a:ext>
            </a:extLst>
          </p:cNvPr>
          <p:cNvSpPr/>
          <p:nvPr/>
        </p:nvSpPr>
        <p:spPr>
          <a:xfrm rot="8100000">
            <a:off x="2726382" y="4492129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二等辺三角形 26">
            <a:extLst>
              <a:ext uri="{FF2B5EF4-FFF2-40B4-BE49-F238E27FC236}">
                <a16:creationId xmlns:a16="http://schemas.microsoft.com/office/drawing/2014/main" id="{91E6A43B-E7D6-4BCD-96BE-A8E19070A95B}"/>
              </a:ext>
            </a:extLst>
          </p:cNvPr>
          <p:cNvSpPr/>
          <p:nvPr/>
        </p:nvSpPr>
        <p:spPr>
          <a:xfrm rot="13500000">
            <a:off x="6098766" y="1287744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二等辺三角形 27">
            <a:extLst>
              <a:ext uri="{FF2B5EF4-FFF2-40B4-BE49-F238E27FC236}">
                <a16:creationId xmlns:a16="http://schemas.microsoft.com/office/drawing/2014/main" id="{CC8FA25A-4F52-4F44-8A1D-5349F08EAE6F}"/>
              </a:ext>
            </a:extLst>
          </p:cNvPr>
          <p:cNvSpPr/>
          <p:nvPr/>
        </p:nvSpPr>
        <p:spPr>
          <a:xfrm rot="13500000">
            <a:off x="6313081" y="1511586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二等辺三角形 28">
            <a:extLst>
              <a:ext uri="{FF2B5EF4-FFF2-40B4-BE49-F238E27FC236}">
                <a16:creationId xmlns:a16="http://schemas.microsoft.com/office/drawing/2014/main" id="{6E2557FB-D3D1-4A85-B965-4A278B76B508}"/>
              </a:ext>
            </a:extLst>
          </p:cNvPr>
          <p:cNvSpPr/>
          <p:nvPr/>
        </p:nvSpPr>
        <p:spPr>
          <a:xfrm rot="13500000">
            <a:off x="6313075" y="1606837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二等辺三角形 29">
            <a:extLst>
              <a:ext uri="{FF2B5EF4-FFF2-40B4-BE49-F238E27FC236}">
                <a16:creationId xmlns:a16="http://schemas.microsoft.com/office/drawing/2014/main" id="{7284AC22-FE21-40D6-9B06-3B596F94080B}"/>
              </a:ext>
            </a:extLst>
          </p:cNvPr>
          <p:cNvSpPr/>
          <p:nvPr/>
        </p:nvSpPr>
        <p:spPr>
          <a:xfrm rot="13500000">
            <a:off x="6455949" y="2197398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二等辺三角形 30">
            <a:extLst>
              <a:ext uri="{FF2B5EF4-FFF2-40B4-BE49-F238E27FC236}">
                <a16:creationId xmlns:a16="http://schemas.microsoft.com/office/drawing/2014/main" id="{A2A6F3E3-91A0-44A7-9B06-F5FDA9E9719B}"/>
              </a:ext>
            </a:extLst>
          </p:cNvPr>
          <p:cNvSpPr/>
          <p:nvPr/>
        </p:nvSpPr>
        <p:spPr>
          <a:xfrm rot="18900000">
            <a:off x="6035126" y="4839805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二等辺三角形 32">
            <a:extLst>
              <a:ext uri="{FF2B5EF4-FFF2-40B4-BE49-F238E27FC236}">
                <a16:creationId xmlns:a16="http://schemas.microsoft.com/office/drawing/2014/main" id="{605DEE0C-3C49-4D7F-926D-3AEA576B92E7}"/>
              </a:ext>
            </a:extLst>
          </p:cNvPr>
          <p:cNvSpPr/>
          <p:nvPr/>
        </p:nvSpPr>
        <p:spPr>
          <a:xfrm rot="8100000">
            <a:off x="5587446" y="4534993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二等辺三角形 33">
            <a:extLst>
              <a:ext uri="{FF2B5EF4-FFF2-40B4-BE49-F238E27FC236}">
                <a16:creationId xmlns:a16="http://schemas.microsoft.com/office/drawing/2014/main" id="{C61D94E0-4557-40BD-B110-A1A42821B3A5}"/>
              </a:ext>
            </a:extLst>
          </p:cNvPr>
          <p:cNvSpPr/>
          <p:nvPr/>
        </p:nvSpPr>
        <p:spPr>
          <a:xfrm rot="8100000">
            <a:off x="5668414" y="4492128"/>
            <a:ext cx="72000" cy="108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D915967-304A-431B-B430-FD9F992BEDF3}"/>
              </a:ext>
            </a:extLst>
          </p:cNvPr>
          <p:cNvSpPr txBox="1"/>
          <p:nvPr/>
        </p:nvSpPr>
        <p:spPr>
          <a:xfrm>
            <a:off x="237705" y="5783164"/>
            <a:ext cx="867333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Supplementary Movie S1. PMC disrupts the interaction between KDELR1 and </a:t>
            </a:r>
            <a:r>
              <a:rPr lang="en-US" altLang="ja-JP" sz="1200" b="1" dirty="0" err="1"/>
              <a:t>BiP</a:t>
            </a:r>
            <a:r>
              <a:rPr lang="en-US" altLang="ja-JP" sz="1200" b="1" dirty="0"/>
              <a:t>.</a:t>
            </a:r>
          </a:p>
          <a:p>
            <a:r>
              <a:rPr lang="en-US" altLang="ja-JP" sz="1200" dirty="0"/>
              <a:t>Time-lapse </a:t>
            </a:r>
            <a:r>
              <a:rPr lang="en-US" altLang="ja-JP" sz="1200" dirty="0" err="1"/>
              <a:t>Fluoppi</a:t>
            </a:r>
            <a:r>
              <a:rPr lang="en-US" altLang="ja-JP" sz="1200" dirty="0"/>
              <a:t> assay movies showing HCT116K (A) and HCT116KB (B) cells treated with 30 µM PMC. Left panels: green fluorescence images. Right panels: merged green fluorescence and bright-field images. White arrows indicate false-positive </a:t>
            </a:r>
            <a:r>
              <a:rPr lang="en-US" altLang="ja-JP" sz="1200" dirty="0" err="1"/>
              <a:t>Fluoppi</a:t>
            </a:r>
            <a:r>
              <a:rPr lang="en-US" altLang="ja-JP" sz="1200" dirty="0"/>
              <a:t> puncta.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27244522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50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45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90000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90000" fill="hold"/>
                                        <p:tgtEl>
                                          <p:spTgt spid="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25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26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7" fill="hold">
                      <p:stCondLst>
                        <p:cond delay="0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0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seq concurrent="1" nextAc="seek">
              <p:cTn id="31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2" fill="hold">
                      <p:stCondLst>
                        <p:cond delay="0"/>
                      </p:stCondLst>
                      <p:childTnLst>
                        <p:par>
                          <p:cTn id="33" fill="hold">
                            <p:stCondLst>
                              <p:cond delay="0"/>
                            </p:stCondLst>
                            <p:childTnLst>
                              <p:par>
                                <p:cTn id="3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5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seq concurrent="1" nextAc="seek">
              <p:cTn id="36" restart="whenNotActive" fill="hold" evtFilter="cancelBubble" nodeType="interactiveSeq">
                <p:stCondLst>
                  <p:cond evt="onClick" delay="0">
                    <p:tgtEl>
                      <p:spTgt spid="1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7" fill="hold">
                      <p:stCondLst>
                        <p:cond delay="0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0" dur="1" fill="hold"/>
                                        <p:tgtEl>
                                          <p:spTgt spid="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5"/>
                  </p:tgtEl>
                </p:cond>
              </p:nextCondLst>
            </p:seq>
            <p:video>
              <p:cMediaNode vol="80000">
                <p:cTn id="41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  <p:video>
              <p:cMediaNode vol="80000">
                <p:cTn id="42" fill="hold" display="0">
                  <p:stCondLst>
                    <p:cond delay="indefinite"/>
                  </p:stCondLst>
                </p:cTn>
                <p:tgtEl>
                  <p:spTgt spid="1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研究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 algn="l">
          <a:defRPr kumimoji="1" sz="1200" dirty="0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110</Words>
  <Application>Microsoft Office PowerPoint</Application>
  <PresentationFormat>画面に合わせる (4:3)</PresentationFormat>
  <Paragraphs>10</Paragraphs>
  <Slides>1</Slides>
  <Notes>0</Notes>
  <HiddenSlides>0</HiddenSlides>
  <MMClips>4</MMClips>
  <ScaleCrop>false</ScaleCrop>
  <HeadingPairs>
    <vt:vector size="6" baseType="variant">
      <vt:variant>
        <vt:lpstr>使用されているフォント</vt:lpstr>
      </vt:variant>
      <vt:variant>
        <vt:i4>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3" baseType="lpstr"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ichi Matsumoto</dc:creator>
  <cp:lastModifiedBy>Kazumasa YOSHIDA</cp:lastModifiedBy>
  <cp:revision>14</cp:revision>
  <dcterms:created xsi:type="dcterms:W3CDTF">2025-10-04T19:45:32Z</dcterms:created>
  <dcterms:modified xsi:type="dcterms:W3CDTF">2025-11-06T07:48:45Z</dcterms:modified>
</cp:coreProperties>
</file>